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90" d="100"/>
          <a:sy n="90" d="100"/>
        </p:scale>
        <p:origin x="1344" y="3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5857727-DB3D-DEF8-C45A-E9964EC9722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 baseline="0">
                <a:latin typeface="Arial" panose="020B0604020202020204" pitchFamily="34" charset="0"/>
                <a:ea typeface="游ゴシック" panose="020B0400000000000000" pitchFamily="50" charset="-128"/>
              </a:defRPr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B7C6D413-1182-49AD-2015-FC896038579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35781A3-5916-A8B6-95A3-5AA860C243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E8916-663E-4740-945E-4417233C0109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5BAE78B-ACEA-C412-8236-B6EAF4646B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A2D4BB7-533D-9C24-2BC3-81A82B8D27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FF7EE-BCDA-4308-B824-9B62081168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79824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4125A25-442E-9736-6746-5B3875037E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A05A7DC-CC71-A7E0-83E9-7999DFD9FC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6EEBCA5-F149-5732-7AB0-85450ABE96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E8916-663E-4740-945E-4417233C0109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3C43727-69F4-CECF-700D-F060D0F967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80AE98F-F894-4E9A-4772-1BABB1CE8F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FF7EE-BCDA-4308-B824-9B62081168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00079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9FAEE7B9-25CC-F65C-44D7-BC6F9818706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4FB1001-3BCA-487B-3D3E-ED1594A6E5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84A4F65-8FF2-4BD2-516C-00D553A89A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E8916-663E-4740-945E-4417233C0109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EE1BAB3-9F8A-2973-F55C-31C4FDF882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1C1270C-C73D-A41C-90B3-4529F48057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FF7EE-BCDA-4308-B824-9B62081168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44323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6BDF3F3-61BD-A986-1011-4639EC24D0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"/>
            <a:ext cx="10515600" cy="803564"/>
          </a:xfrm>
        </p:spPr>
        <p:txBody>
          <a:bodyPr>
            <a:normAutofit/>
          </a:bodyPr>
          <a:lstStyle>
            <a:lvl1pPr>
              <a:defRPr sz="3200" baseline="0"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defRPr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00EF453-BE28-56B8-C683-81A8C96200C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025236"/>
            <a:ext cx="10515600" cy="4777259"/>
          </a:xfrm>
        </p:spPr>
        <p:txBody>
          <a:bodyPr/>
          <a:lstStyle>
            <a:lvl1pPr>
              <a:defRPr baseline="0">
                <a:latin typeface="ＭＳ ゴシック" panose="020B0609070205080204" pitchFamily="49" charset="-128"/>
                <a:ea typeface="游ゴシック" panose="020B0400000000000000" pitchFamily="50" charset="-128"/>
                <a:cs typeface="Arial" panose="020B0604020202020204" pitchFamily="34" charset="0"/>
              </a:defRPr>
            </a:lvl1pPr>
            <a:lvl2pPr>
              <a:defRPr baseline="0">
                <a:latin typeface="ＭＳ ゴシック" panose="020B0609070205080204" pitchFamily="49" charset="-128"/>
                <a:ea typeface="游ゴシック" panose="020B0400000000000000" pitchFamily="50" charset="-128"/>
                <a:cs typeface="Arial" panose="020B0604020202020204" pitchFamily="34" charset="0"/>
              </a:defRPr>
            </a:lvl2pPr>
            <a:lvl3pPr>
              <a:defRPr baseline="0">
                <a:latin typeface="ＭＳ ゴシック" panose="020B0609070205080204" pitchFamily="49" charset="-128"/>
                <a:ea typeface="游ゴシック" panose="020B0400000000000000" pitchFamily="50" charset="-128"/>
                <a:cs typeface="Arial" panose="020B0604020202020204" pitchFamily="34" charset="0"/>
              </a:defRPr>
            </a:lvl3pPr>
            <a:lvl4pPr>
              <a:defRPr baseline="0">
                <a:latin typeface="ＭＳ ゴシック" panose="020B0609070205080204" pitchFamily="49" charset="-128"/>
                <a:ea typeface="游ゴシック" panose="020B0400000000000000" pitchFamily="50" charset="-128"/>
                <a:cs typeface="Arial" panose="020B0604020202020204" pitchFamily="34" charset="0"/>
              </a:defRPr>
            </a:lvl4pPr>
            <a:lvl5pPr>
              <a:defRPr baseline="0">
                <a:latin typeface="ＭＳ ゴシック" panose="020B0609070205080204" pitchFamily="49" charset="-128"/>
                <a:ea typeface="游ゴシック" panose="020B0400000000000000" pitchFamily="50" charset="-128"/>
                <a:cs typeface="Arial" panose="020B0604020202020204" pitchFamily="34" charset="0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127DA5D-4282-1C1B-2E2F-4B22B08052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E8916-663E-4740-945E-4417233C0109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C3BA0D4-9616-BE65-B38B-936573320C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B4B6256-231D-42B0-E9DF-916F1DCB68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FF7EE-BCDA-4308-B824-9B62081168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76959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44C31A7-CC33-B31E-8C67-0CAA2A3BB0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F8FCCBE-5BDA-3FF7-3634-02F30E71E9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DC1738B-74E7-EBEC-4FC9-04A660C535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E8916-663E-4740-945E-4417233C0109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C6A185E-156D-80D3-952E-31FF113160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A80E39D-9102-5038-F18D-BF81998E4A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FF7EE-BCDA-4308-B824-9B62081168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02037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09B84B5-3590-ADC8-08F9-7FDB420081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93AACE5-F445-6F61-0FED-87056A18D73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0BDC524-B36E-479A-0EA0-2A196019DC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33F2F1A-513A-0451-625C-8A30371E84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E8916-663E-4740-945E-4417233C0109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50A9BFE-110E-C46F-D41C-EDF9E3B7D3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379F8F5-BAAA-527C-808C-9428A7F0A0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FF7EE-BCDA-4308-B824-9B62081168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36494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66DE9A1-8B09-D990-C25E-413C52F612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FE74B4E-5E7E-1010-505D-07A2936362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5C7F14E-1EA2-1F7D-1F15-CA6EE229970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950BBE2-D5D4-6CC3-9D41-F69DF7B05FD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C7E6781-5EA9-9A03-B88D-725F5E2DE49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168BF554-4B61-2372-43CB-DC470B820E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E8916-663E-4740-945E-4417233C0109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FBF719C2-FA7D-CF2C-7403-77B533D22D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DA596B10-B88F-ADB4-AB86-7FF15F4884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FF7EE-BCDA-4308-B824-9B62081168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6068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1DA050A-D3D4-72E6-9843-636D630E1B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0"/>
            <a:ext cx="10541000" cy="877455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90636C5-321F-B2E5-7A94-77F8DBD12B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E8916-663E-4740-945E-4417233C0109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C1FE6256-FBCB-35B1-2128-5ACE16F76C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F89E15D-9C89-66CE-9C5F-CA172CDC44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FF7EE-BCDA-4308-B824-9B62081168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08094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A7ACB287-27DB-0C8B-5526-F59BBD0006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E8916-663E-4740-945E-4417233C0109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D59F7EA2-4D48-5250-4AEE-64A1474BD8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845CE4F-9C18-14C5-0B8C-5210AB96F7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FF7EE-BCDA-4308-B824-9B62081168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50951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05E77CF-D3AA-F64B-C132-ED7BE4434B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52F9D12-AF59-3ABC-8F2D-3F5E7E28FD8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CD1318D-23FC-0BF3-73C1-0EEA9A7B4EA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06E8439-EF1D-A271-322A-21ABF0BDBF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E8916-663E-4740-945E-4417233C0109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322B1F5-2FFB-A83F-FC82-726AB73620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16FEC9B-3E83-EAB5-E427-6BB2122874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FF7EE-BCDA-4308-B824-9B62081168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70847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0A16366-59DC-125A-7620-ABBC2F3BE6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6FBE2E9-396E-37F4-8A25-9D0687DEA74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9ECC07F-DC0C-7587-89FC-A92E8DFC92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9066410-E9FF-B750-3E42-ACA21DBF6C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E8916-663E-4740-945E-4417233C0109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BE8EF47-657E-965C-AD6D-EA9A9547BA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F6BD140-1623-0F1C-21BF-3E7CB98DA4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FF7EE-BCDA-4308-B824-9B62081168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9673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59F14E5-FEE5-A96F-0028-FCCA99ACB7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21882C6-5679-FFD3-8BDC-CF1CB2ECAA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04F499A-FD4F-EE7E-D5CD-7020B33AF13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E3E8916-663E-4740-945E-4417233C0109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CF0D7C0-05F3-4B06-8B16-9B021036F63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FC75559-549D-7BE1-BBA8-7F58B96242F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E4FF7EE-BCDA-4308-B824-9B62081168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99849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AE2B508-E47D-1F56-5884-7A67F7CC7A18}"/>
              </a:ext>
            </a:extLst>
          </p:cNvPr>
          <p:cNvSpPr txBox="1"/>
          <p:nvPr/>
        </p:nvSpPr>
        <p:spPr>
          <a:xfrm>
            <a:off x="3605600" y="6384173"/>
            <a:ext cx="50125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Registration</a:t>
            </a:r>
            <a:r>
              <a: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eriod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:</a:t>
            </a:r>
            <a:r>
              <a: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　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NOV/2021-OCT/2023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F059AAF-D278-FA14-0048-92FB4617A79E}"/>
              </a:ext>
            </a:extLst>
          </p:cNvPr>
          <p:cNvSpPr txBox="1"/>
          <p:nvPr/>
        </p:nvSpPr>
        <p:spPr>
          <a:xfrm>
            <a:off x="1943109" y="491357"/>
            <a:ext cx="6438891" cy="175432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Registration (N = </a:t>
            </a:r>
            <a:r>
              <a:rPr kumimoji="1" lang="en-US" altLang="ja-JP" sz="1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60)</a:t>
            </a: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Patients who had not yet initiated olaparib (N = 9)</a:t>
            </a: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Patients who were receiving olaparib without evidence of disease progression (N = 31)</a:t>
            </a: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Patients who had already completed olaparib therapy (N = 20)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9B83C51C-8044-9804-0CA8-3B7871FE2FF5}"/>
              </a:ext>
            </a:extLst>
          </p:cNvPr>
          <p:cNvSpPr txBox="1"/>
          <p:nvPr/>
        </p:nvSpPr>
        <p:spPr>
          <a:xfrm>
            <a:off x="2834641" y="3882938"/>
            <a:ext cx="4584909" cy="12003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End of treatment with olaparib</a:t>
            </a:r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(N = </a:t>
            </a:r>
            <a:r>
              <a:rPr kumimoji="1" lang="en-US" altLang="ja-JP" sz="1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45, 75.0%)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                 Reason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　　　　  </a:t>
            </a:r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Disease progression (N = </a:t>
            </a:r>
            <a:r>
              <a:rPr kumimoji="1" lang="en-US" altLang="ja-JP" sz="1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45, 100%)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                 Toxicity (0)</a:t>
            </a:r>
            <a:endParaRPr kumimoji="1" lang="en-US" altLang="ja-JP" sz="18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16689B3-C16C-833F-B652-9D0B4B94BA03}"/>
              </a:ext>
            </a:extLst>
          </p:cNvPr>
          <p:cNvSpPr txBox="1"/>
          <p:nvPr/>
        </p:nvSpPr>
        <p:spPr>
          <a:xfrm>
            <a:off x="2604997" y="5848028"/>
            <a:ext cx="507863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Blood</a:t>
            </a:r>
            <a:r>
              <a: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collection</a:t>
            </a:r>
            <a:r>
              <a: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t</a:t>
            </a:r>
            <a:r>
              <a: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end</a:t>
            </a:r>
            <a:r>
              <a: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of</a:t>
            </a:r>
            <a:r>
              <a: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treatment</a:t>
            </a:r>
            <a:r>
              <a:rPr kumimoji="1" lang="en-US" altLang="ja-JP" sz="1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(N = 42</a:t>
            </a:r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, 70.0%)</a:t>
            </a:r>
            <a:endParaRPr kumimoji="1" lang="ja-JP" altLang="en-US" sz="18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B9097CA-79D0-A3B5-F9C2-050B427078EB}"/>
              </a:ext>
            </a:extLst>
          </p:cNvPr>
          <p:cNvSpPr txBox="1"/>
          <p:nvPr/>
        </p:nvSpPr>
        <p:spPr>
          <a:xfrm>
            <a:off x="3156031" y="2862297"/>
            <a:ext cx="3599062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Blood collection at baseline (N = </a:t>
            </a:r>
            <a:r>
              <a:rPr kumimoji="1" lang="en-US" altLang="ja-JP" sz="1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60)</a:t>
            </a:r>
            <a:endParaRPr kumimoji="1" lang="ja-JP" altLang="en-US" sz="18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0" name="矢印: 下 9">
            <a:extLst>
              <a:ext uri="{FF2B5EF4-FFF2-40B4-BE49-F238E27FC236}">
                <a16:creationId xmlns:a16="http://schemas.microsoft.com/office/drawing/2014/main" id="{4FA41794-6FE4-BDCA-5602-EAF4E9BBD18D}"/>
              </a:ext>
            </a:extLst>
          </p:cNvPr>
          <p:cNvSpPr/>
          <p:nvPr/>
        </p:nvSpPr>
        <p:spPr>
          <a:xfrm>
            <a:off x="4847853" y="2329089"/>
            <a:ext cx="387096" cy="521260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1" name="矢印: 下 10">
            <a:extLst>
              <a:ext uri="{FF2B5EF4-FFF2-40B4-BE49-F238E27FC236}">
                <a16:creationId xmlns:a16="http://schemas.microsoft.com/office/drawing/2014/main" id="{DEAF822D-BBDB-7ECA-5E2B-685549A3B91F}"/>
              </a:ext>
            </a:extLst>
          </p:cNvPr>
          <p:cNvSpPr/>
          <p:nvPr/>
        </p:nvSpPr>
        <p:spPr>
          <a:xfrm>
            <a:off x="4847853" y="3311634"/>
            <a:ext cx="387096" cy="521260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2" name="矢印: 下 11">
            <a:extLst>
              <a:ext uri="{FF2B5EF4-FFF2-40B4-BE49-F238E27FC236}">
                <a16:creationId xmlns:a16="http://schemas.microsoft.com/office/drawing/2014/main" id="{4E2F48B5-A042-E93D-DF0F-AEF0F620F428}"/>
              </a:ext>
            </a:extLst>
          </p:cNvPr>
          <p:cNvSpPr/>
          <p:nvPr/>
        </p:nvSpPr>
        <p:spPr>
          <a:xfrm>
            <a:off x="4847853" y="5213778"/>
            <a:ext cx="387096" cy="521260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C1CB797-2926-53A0-BC4C-73FC9ACA054E}"/>
              </a:ext>
            </a:extLst>
          </p:cNvPr>
          <p:cNvSpPr txBox="1"/>
          <p:nvPr/>
        </p:nvSpPr>
        <p:spPr>
          <a:xfrm>
            <a:off x="5604857" y="5213778"/>
            <a:ext cx="4157548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ood collection wasn’t performed (N = 3</a:t>
            </a:r>
            <a:r>
              <a:rPr kumimoji="1" lang="en-US" altLang="ja-JP" dirty="0"/>
              <a:t>)</a:t>
            </a:r>
            <a:endParaRPr kumimoji="1" lang="ja-JP" altLang="en-US" dirty="0"/>
          </a:p>
        </p:txBody>
      </p:sp>
      <p:cxnSp>
        <p:nvCxnSpPr>
          <p:cNvPr id="15" name="直線矢印コネクタ 14">
            <a:extLst>
              <a:ext uri="{FF2B5EF4-FFF2-40B4-BE49-F238E27FC236}">
                <a16:creationId xmlns:a16="http://schemas.microsoft.com/office/drawing/2014/main" id="{7434A6FD-9297-657D-5893-30827B65ACCC}"/>
              </a:ext>
            </a:extLst>
          </p:cNvPr>
          <p:cNvCxnSpPr>
            <a:endCxn id="3" idx="1"/>
          </p:cNvCxnSpPr>
          <p:nvPr/>
        </p:nvCxnSpPr>
        <p:spPr>
          <a:xfrm>
            <a:off x="5100320" y="5384800"/>
            <a:ext cx="504537" cy="1364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56070599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3</TotalTime>
  <Words>116</Words>
  <Application>Microsoft Office PowerPoint</Application>
  <PresentationFormat>ワイド画面</PresentationFormat>
  <Paragraphs>1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ゴシック</vt:lpstr>
      <vt:lpstr>游ゴシック</vt:lpstr>
      <vt:lpstr>游ゴシック Light</vt:lpstr>
      <vt:lpstr>Arial</vt:lpstr>
      <vt:lpstr>Times New Roman</vt:lpstr>
      <vt:lpstr>1_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itomi Sakai</dc:creator>
  <cp:lastModifiedBy>Hitomi Sakai</cp:lastModifiedBy>
  <cp:revision>4</cp:revision>
  <dcterms:created xsi:type="dcterms:W3CDTF">2025-12-22T10:52:13Z</dcterms:created>
  <dcterms:modified xsi:type="dcterms:W3CDTF">2026-03-12T10:06:49Z</dcterms:modified>
</cp:coreProperties>
</file>